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781800" cy="99107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E15D51-F781-49C9-8A66-44238842A1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2BE5B9-FB37-41CB-8F4B-8435E83B1B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3E0465-D4E9-441D-80F5-141DC75D622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7650A9-411A-46FE-B3C7-AD3E64EA158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EB9B99-EB25-4C6B-96E5-D55D364179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B6FF39-924C-4B6F-A51C-2D1B5952020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3B4BCF-7074-40EA-A2F2-CF0E9539BD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063546-A531-4528-977D-5505337949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F898E5-9D73-405C-AEF7-3BB1E81823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7A87B6-7960-4E60-BC43-B861EBCC2C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03371F-A6D1-4B71-B8C8-4FFFC4DD56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C59F4D-854F-4B69-B49F-B64F745B43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4ADD6C-3A23-4146-8A53-89D447381A28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76320" y="1295280"/>
            <a:ext cx="8915400" cy="3733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"/>
          <p:cNvSpPr/>
          <p:nvPr/>
        </p:nvSpPr>
        <p:spPr>
          <a:xfrm>
            <a:off x="250920" y="333360"/>
            <a:ext cx="8713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42840" y="260280"/>
            <a:ext cx="9056880" cy="356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Supplementary figure 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Description of </a:t>
            </a:r>
            <a:r>
              <a:rPr b="1" i="1" lang="en-GB" sz="1200" spc="-1" strike="noStrike">
                <a:solidFill>
                  <a:srgbClr val="000000"/>
                </a:solidFill>
                <a:latin typeface="Times New Roman"/>
              </a:rPr>
              <a:t>fak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 targeting construct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Supp Fig1 shows the construction of the targeting vector, carrying three loxP sites in an intronic region of the 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fak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gene (LP3), thus allowing generation of  a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fak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null allele (this study) as well as a conditional (loxP flanked) allele (see [1])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A 6.7 Kb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Eco RI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-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Pvu II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fragment from mouse (129Sv)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fak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genomic DNA regions was subcloned into pKASAL3 (pUC8 derived, N.H.K. unpublished) vector. In this vector, a drug marker cassette containing both neomycin phosphotransferase gene and Herpes simplex thymidine kinase gene (MC1-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tk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-pA + PGK-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neo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-pA) flanked by two loxP sites (LTNL cassette [2]) was inserted 5' of an exon (Xba I site) which codes a part of the ATP binding loop of the FAK kinase domain. A third loxP site was introduced 3' of the same exon (between two Hind III sites) using synthetic oligonucleotides resulting in the deletion of both Hind III sites. A Not I / Sal I digestion fragment of this construct was cloned into a Csk targeting vector ([3]) digested with Not I and Xho I to generate the FAK-LP3 targeting vector, which also contained Diptheria toxin A gene fragment (MC1-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DTA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) to enable counter selection. Restriction sites marked as follows: Xh =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XhoI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, H =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Hind III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, B =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BamHI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, E =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Eco RI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, P =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Pvu I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1. McLean GW, Komiyama NH, Serrels B, Asano H, Reynolds L, Conti F, Hodivala-Dilke K, Metzger D, Chambon P, Grant SG, Frame MC: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Specific deletion of focal adhesion kinase suppresses tumor formation and blocks malignant progression.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Genes Dev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2004,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18: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2998-3003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2. Mombaerts P, Wang F, Dulac C, Chao SK, Nemes A, Mendelsohn M, Edmondson J, Axel R: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Visualizing an olfactory sensory map.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Cell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1996,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87: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675-686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3. Nada S, Yagi T, Takeda H, Tokunaga T, Nakagawa H, Ikawa Y, Okada M, Aizawa S: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Constitutive activation of Src family kinases in mouse embryos that lack Csk.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Cell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1993,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73: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1125-1135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2-05-15T14:36:11Z</dcterms:created>
  <dc:creator>Charlesworth</dc:creator>
  <dc:description/>
  <dc:language>en-US</dc:language>
  <cp:lastModifiedBy>pc3</cp:lastModifiedBy>
  <dcterms:modified xsi:type="dcterms:W3CDTF">2006-06-09T14:08:39Z</dcterms:modified>
  <cp:revision>5</cp:revision>
  <dc:subject/>
  <dc:title>PowerPoint Presentation</dc:title>
</cp:coreProperties>
</file>